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67" autoAdjust="0"/>
    <p:restoredTop sz="96357" autoAdjust="0"/>
  </p:normalViewPr>
  <p:slideViewPr>
    <p:cSldViewPr snapToGrid="0">
      <p:cViewPr varScale="1">
        <p:scale>
          <a:sx n="123" d="100"/>
          <a:sy n="123" d="100"/>
        </p:scale>
        <p:origin x="270" y="10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0AEFB6-5251-4159-9882-62FB11D682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347EA6-6484-4561-8E8D-AF6700C366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F559F0-582E-4C00-9DCE-1710FB7919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FC025-BA73-4FC4-8726-C5BEC95C758B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634483-DCE7-4AA7-89A1-215830CD6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30A1EE-DC72-43BB-BC74-6389F7D32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AD6DA-6467-433A-AEF8-0D5545FC22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0925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6E9FA7-41A5-4C5C-884A-C3FE6D31E6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D8683E-A714-4F38-B159-946816B2DA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3F2066-D54B-4D41-8C42-0A4AFE43A0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FC025-BA73-4FC4-8726-C5BEC95C758B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1212CC-1276-41FB-AB5A-090CE8FEF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B33711-AC14-4B35-8EBB-0DFCE1491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AD6DA-6467-433A-AEF8-0D5545FC22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7049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F7E86E-CAA2-4C8C-99A1-F25CD0F257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FC5B53-01AD-4150-8A1F-412967A539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9B0833-E78C-4ACD-A0E5-8E6A458AA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FC025-BA73-4FC4-8726-C5BEC95C758B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9A8CBC-CB68-4824-86B9-F365A2D78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BEFEE4-EE92-4057-991C-3F995EEA98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AD6DA-6467-433A-AEF8-0D5545FC22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0717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2FA466-9703-4254-995E-AD0A2F947E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522ABD-A825-4F04-9251-58956F127A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FDAF70-725E-4011-9A73-0DFC7CEB79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FC025-BA73-4FC4-8726-C5BEC95C758B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61FFF1-E286-4C31-8D38-4DD424FB2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73A15A-8984-4191-AD9C-BEEEF1CD23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AD6DA-6467-433A-AEF8-0D5545FC22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2802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7E98FB-F5BC-4554-A741-D99AB84CDC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0812DC-C180-49BB-8006-6885700BE5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2A673C-6A5D-4718-A2BC-24F95BD724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FC025-BA73-4FC4-8726-C5BEC95C758B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9FF138-C20D-4408-AA45-197D7D7B2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A85BAD-64CE-44EC-8F1D-0794A1253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AD6DA-6467-433A-AEF8-0D5545FC22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1633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3296D1-F5D7-4833-8B02-D94EADCB37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DD58A0-4A44-451A-9588-4163E85180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5F0B75-8041-4FEC-BF16-EEF6C70B90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028453-C262-4164-B2BA-67AB666EB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FC025-BA73-4FC4-8726-C5BEC95C758B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5AE34F-00E7-4DDF-A56B-8A6AE09F9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18EF39-5E6D-4BE7-A89A-FF34EA225E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AD6DA-6467-433A-AEF8-0D5545FC22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6014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0D0CDF-C61D-4B6E-B416-6B41AD7A46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AEA3AE-4E68-4F11-8F73-404F8CAD03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B0B1F8-E9CB-43B4-84D2-9BA5A10C0C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838124C-47CB-4414-86D2-7AFABC2ECD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3D4D18-7E38-42EC-986B-87F47FE4A9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0B22E4C-EC23-41CB-AE13-B5016A320F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FC025-BA73-4FC4-8726-C5BEC95C758B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E0FB187-5F04-4494-866C-B6568732C8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55BDE6-520B-4B4A-8A11-08B72B134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AD6DA-6467-433A-AEF8-0D5545FC22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9211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84EB1C-81AF-4466-97D5-CF3BC82936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17625C-A9CA-4D3F-9F42-8F9829448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FC025-BA73-4FC4-8726-C5BEC95C758B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E5E8DE-F29E-4E2D-B39E-0F37C1DE5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B0504A-42F8-4923-9617-A6B1FCF4B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AD6DA-6467-433A-AEF8-0D5545FC22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9533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557DE5-D4D7-4FD1-BB94-74D12714B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FC025-BA73-4FC4-8726-C5BEC95C758B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3E5386-51F5-4A50-8F2E-FFFD60BE8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BF0687-1E0C-41C6-986C-EA65B887F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AD6DA-6467-433A-AEF8-0D5545FC22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92928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F6EB71-199D-4128-96D4-4DDD4FFD2A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847818-5EBD-4AA6-9E8A-E055C01E95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D00A9F-A15E-4E2E-BAF6-1442FB8FAB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267C5A-1867-4D94-AF7F-5F70CC913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FC025-BA73-4FC4-8726-C5BEC95C758B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39C80A-4CEA-49DC-9C45-0D4BEEBEB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F687D4-ACE2-4699-AB7A-A9DD1F7FD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AD6DA-6467-433A-AEF8-0D5545FC22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47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897F36-6EB4-4FF5-A3B5-9115C12015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18A33B-C99E-476D-97F3-4DB47FF6F5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56F94A-6C9F-49A9-9F19-22747F045C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AE4377-DE49-4575-8967-1D8934D37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FC025-BA73-4FC4-8726-C5BEC95C758B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082E4B-2478-4121-A989-BCED6548DD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212460-F519-4628-9B0E-35FD35379E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AD6DA-6467-433A-AEF8-0D5545FC22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3639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387BFDF-9DE2-4475-B973-166635CC63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E15825-930D-4270-B8A5-715FF76E36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4BE366-3CE3-49B4-9113-63605844B3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6FC025-BA73-4FC4-8726-C5BEC95C758B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4560DF-839B-41CF-801F-55E9E92F88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AD83FB-751C-425A-AC55-CF1C1900CD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AAD6DA-6467-433A-AEF8-0D5545FC22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1633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Rectangle 37">
            <a:extLst>
              <a:ext uri="{FF2B5EF4-FFF2-40B4-BE49-F238E27FC236}">
                <a16:creationId xmlns:a16="http://schemas.microsoft.com/office/drawing/2014/main" id="{186F28EA-B51A-45B5-A092-8E0C5AFAEB1F}"/>
              </a:ext>
            </a:extLst>
          </p:cNvPr>
          <p:cNvSpPr/>
          <p:nvPr/>
        </p:nvSpPr>
        <p:spPr>
          <a:xfrm>
            <a:off x="691137" y="995827"/>
            <a:ext cx="3200337" cy="179411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cxnSp>
        <p:nvCxnSpPr>
          <p:cNvPr id="20" name="AutoShape 83">
            <a:extLst>
              <a:ext uri="{FF2B5EF4-FFF2-40B4-BE49-F238E27FC236}">
                <a16:creationId xmlns:a16="http://schemas.microsoft.com/office/drawing/2014/main" id="{F70D7AB1-DB6D-473D-96A6-E328F8FD1D87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2139576" y="1947652"/>
            <a:ext cx="302711" cy="4486"/>
          </a:xfrm>
          <a:prstGeom prst="straightConnector1">
            <a:avLst/>
          </a:prstGeom>
          <a:noFill/>
          <a:ln w="9525">
            <a:solidFill>
              <a:schemeClr val="bg2">
                <a:lumMod val="2500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D4D2D0"/>
                  </a:outerShdw>
                </a:effectLst>
              </a14:hiddenEffects>
            </a:ext>
          </a:extLst>
        </p:spPr>
      </p:cxnSp>
      <p:sp>
        <p:nvSpPr>
          <p:cNvPr id="22" name="Rectangle 82">
            <a:extLst>
              <a:ext uri="{FF2B5EF4-FFF2-40B4-BE49-F238E27FC236}">
                <a16:creationId xmlns:a16="http://schemas.microsoft.com/office/drawing/2014/main" id="{595B255D-9F93-426C-AC11-72D4FD2632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5164" y="2080741"/>
            <a:ext cx="472030" cy="1622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>
                <a:solidFill>
                  <a:srgbClr val="E1CF6C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omparison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361FEE95-4D12-4E2A-83EE-1E07EC71F5AE}"/>
              </a:ext>
            </a:extLst>
          </p:cNvPr>
          <p:cNvSpPr/>
          <p:nvPr/>
        </p:nvSpPr>
        <p:spPr>
          <a:xfrm>
            <a:off x="424860" y="995827"/>
            <a:ext cx="177886" cy="179411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</a:rPr>
              <a:t>T0 – T1 (6 months)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8AF0195D-CE20-4C42-A25C-11627FC417B0}"/>
              </a:ext>
            </a:extLst>
          </p:cNvPr>
          <p:cNvSpPr/>
          <p:nvPr/>
        </p:nvSpPr>
        <p:spPr>
          <a:xfrm>
            <a:off x="697373" y="507113"/>
            <a:ext cx="3194101" cy="30459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</a:rPr>
              <a:t>1. Evaluation of service activity 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E4445738-9EC2-4C5C-9465-4933247495D1}"/>
              </a:ext>
            </a:extLst>
          </p:cNvPr>
          <p:cNvSpPr/>
          <p:nvPr/>
        </p:nvSpPr>
        <p:spPr>
          <a:xfrm>
            <a:off x="4816760" y="506275"/>
            <a:ext cx="3273031" cy="30459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</a:rPr>
              <a:t>2. Evaluation of quality of life, service satisfaction and economic outcomes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1FF5C275-D48B-4AC7-A618-5874C2A37581}"/>
              </a:ext>
            </a:extLst>
          </p:cNvPr>
          <p:cNvSpPr/>
          <p:nvPr/>
        </p:nvSpPr>
        <p:spPr>
          <a:xfrm>
            <a:off x="8945671" y="507113"/>
            <a:ext cx="3061563" cy="2966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</a:rPr>
              <a:t>3. Evaluation of intervention implementation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69" name="Right Brace 68">
            <a:extLst>
              <a:ext uri="{FF2B5EF4-FFF2-40B4-BE49-F238E27FC236}">
                <a16:creationId xmlns:a16="http://schemas.microsoft.com/office/drawing/2014/main" id="{2E577C84-B769-44EA-BAB3-F2893A20745A}"/>
              </a:ext>
            </a:extLst>
          </p:cNvPr>
          <p:cNvSpPr/>
          <p:nvPr/>
        </p:nvSpPr>
        <p:spPr>
          <a:xfrm>
            <a:off x="4002561" y="1009681"/>
            <a:ext cx="226075" cy="570951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70" name="Left Brace 69">
            <a:extLst>
              <a:ext uri="{FF2B5EF4-FFF2-40B4-BE49-F238E27FC236}">
                <a16:creationId xmlns:a16="http://schemas.microsoft.com/office/drawing/2014/main" id="{F863F94E-13D3-4A32-9C22-B8FED0A0029B}"/>
              </a:ext>
            </a:extLst>
          </p:cNvPr>
          <p:cNvSpPr/>
          <p:nvPr/>
        </p:nvSpPr>
        <p:spPr>
          <a:xfrm>
            <a:off x="4490650" y="1003126"/>
            <a:ext cx="234019" cy="571607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F8F4D0A2-47E0-4220-ABE1-085E783D9041}"/>
              </a:ext>
            </a:extLst>
          </p:cNvPr>
          <p:cNvSpPr/>
          <p:nvPr/>
        </p:nvSpPr>
        <p:spPr>
          <a:xfrm>
            <a:off x="4243336" y="2968615"/>
            <a:ext cx="226075" cy="20581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</a:rPr>
              <a:t>Consideration of data triangulation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D018D0CC-384B-4A25-8F6A-99E8BF44BF01}"/>
              </a:ext>
            </a:extLst>
          </p:cNvPr>
          <p:cNvSpPr/>
          <p:nvPr/>
        </p:nvSpPr>
        <p:spPr>
          <a:xfrm>
            <a:off x="4824195" y="995827"/>
            <a:ext cx="3265596" cy="17916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chemeClr val="bg2">
                    <a:lumMod val="75000"/>
                  </a:schemeClr>
                </a:solidFill>
              </a:rPr>
              <a:t>Collection of health, satisfaction and economic outcomes has not started yet</a:t>
            </a:r>
            <a:endParaRPr lang="en-GB" sz="800" dirty="0">
              <a:solidFill>
                <a:schemeClr val="bg2">
                  <a:lumMod val="75000"/>
                </a:schemeClr>
              </a:solidFill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DFB0F432-EB6F-4C10-A7C8-5539235140C1}"/>
              </a:ext>
            </a:extLst>
          </p:cNvPr>
          <p:cNvSpPr/>
          <p:nvPr/>
        </p:nvSpPr>
        <p:spPr>
          <a:xfrm>
            <a:off x="8951499" y="995827"/>
            <a:ext cx="3061563" cy="572599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76" name="Right Brace 75">
            <a:extLst>
              <a:ext uri="{FF2B5EF4-FFF2-40B4-BE49-F238E27FC236}">
                <a16:creationId xmlns:a16="http://schemas.microsoft.com/office/drawing/2014/main" id="{954D5417-F1BA-45F8-B1A0-F7794E69A0C0}"/>
              </a:ext>
            </a:extLst>
          </p:cNvPr>
          <p:cNvSpPr/>
          <p:nvPr/>
        </p:nvSpPr>
        <p:spPr>
          <a:xfrm>
            <a:off x="8168931" y="1003327"/>
            <a:ext cx="226075" cy="5706144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77" name="Left Brace 76">
            <a:extLst>
              <a:ext uri="{FF2B5EF4-FFF2-40B4-BE49-F238E27FC236}">
                <a16:creationId xmlns:a16="http://schemas.microsoft.com/office/drawing/2014/main" id="{21789183-B343-426E-B8C5-B5DA7F8531B7}"/>
              </a:ext>
            </a:extLst>
          </p:cNvPr>
          <p:cNvSpPr/>
          <p:nvPr/>
        </p:nvSpPr>
        <p:spPr>
          <a:xfrm>
            <a:off x="8628825" y="1005753"/>
            <a:ext cx="245545" cy="571867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D229E21D-001D-43E1-9C02-2A668E66BD46}"/>
              </a:ext>
            </a:extLst>
          </p:cNvPr>
          <p:cNvSpPr/>
          <p:nvPr/>
        </p:nvSpPr>
        <p:spPr>
          <a:xfrm>
            <a:off x="8384429" y="2956806"/>
            <a:ext cx="226075" cy="20581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</a:rPr>
              <a:t>Consideration of data triangulation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6C5ABDCE-91DC-4494-9F1D-6476509776E1}"/>
              </a:ext>
            </a:extLst>
          </p:cNvPr>
          <p:cNvSpPr/>
          <p:nvPr/>
        </p:nvSpPr>
        <p:spPr>
          <a:xfrm>
            <a:off x="4816248" y="4896864"/>
            <a:ext cx="3265595" cy="180884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dirty="0"/>
          </a:p>
        </p:txBody>
      </p:sp>
      <p:graphicFrame>
        <p:nvGraphicFramePr>
          <p:cNvPr id="93" name="Table 10">
            <a:extLst>
              <a:ext uri="{FF2B5EF4-FFF2-40B4-BE49-F238E27FC236}">
                <a16:creationId xmlns:a16="http://schemas.microsoft.com/office/drawing/2014/main" id="{AF2E777B-2326-49DA-A0DC-64110A4A7A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8127706"/>
              </p:ext>
            </p:extLst>
          </p:nvPr>
        </p:nvGraphicFramePr>
        <p:xfrm>
          <a:off x="4900050" y="5527248"/>
          <a:ext cx="1238823" cy="40644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406447"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chemeClr val="tx1"/>
                          </a:solidFill>
                        </a:rPr>
                        <a:t>Primary Care Mental Health Services</a:t>
                      </a:r>
                      <a:endParaRPr lang="en-GB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95" name="Table 10">
            <a:extLst>
              <a:ext uri="{FF2B5EF4-FFF2-40B4-BE49-F238E27FC236}">
                <a16:creationId xmlns:a16="http://schemas.microsoft.com/office/drawing/2014/main" id="{74954029-DB42-4DDB-812F-36C280E6A0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6107989"/>
              </p:ext>
            </p:extLst>
          </p:nvPr>
        </p:nvGraphicFramePr>
        <p:xfrm>
          <a:off x="4918919" y="6053857"/>
          <a:ext cx="1238823" cy="49776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497766"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chemeClr val="tx1"/>
                          </a:solidFill>
                        </a:rPr>
                        <a:t>Secondary Care Mental Health services </a:t>
                      </a:r>
                      <a:endParaRPr lang="en-GB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sp>
        <p:nvSpPr>
          <p:cNvPr id="107" name="Rectangle 106">
            <a:extLst>
              <a:ext uri="{FF2B5EF4-FFF2-40B4-BE49-F238E27FC236}">
                <a16:creationId xmlns:a16="http://schemas.microsoft.com/office/drawing/2014/main" id="{3870EC73-0985-43B3-BAAB-52B489CF2FC1}"/>
              </a:ext>
            </a:extLst>
          </p:cNvPr>
          <p:cNvSpPr/>
          <p:nvPr/>
        </p:nvSpPr>
        <p:spPr>
          <a:xfrm>
            <a:off x="9211132" y="1180890"/>
            <a:ext cx="2571384" cy="68920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chemeClr val="tx1"/>
                </a:solidFill>
              </a:rPr>
              <a:t>Objectives of the Peterborough Exempla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chemeClr val="tx1"/>
                </a:solidFill>
              </a:rPr>
              <a:t>Feedback from staff members across partn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chemeClr val="tx1"/>
                </a:solidFill>
              </a:rPr>
              <a:t>Feedback from PPI Group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chemeClr val="tx1"/>
                </a:solidFill>
              </a:rPr>
              <a:t>Programme Theory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498DBD40-9AD2-4E48-9206-268B4E440844}"/>
              </a:ext>
            </a:extLst>
          </p:cNvPr>
          <p:cNvSpPr/>
          <p:nvPr/>
        </p:nvSpPr>
        <p:spPr>
          <a:xfrm>
            <a:off x="9199669" y="3454558"/>
            <a:ext cx="838119" cy="46600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</a:rPr>
              <a:t>Groups of participants: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435AC637-B3C9-4799-97AF-26420176B831}"/>
              </a:ext>
            </a:extLst>
          </p:cNvPr>
          <p:cNvSpPr/>
          <p:nvPr/>
        </p:nvSpPr>
        <p:spPr>
          <a:xfrm>
            <a:off x="10224537" y="3396450"/>
            <a:ext cx="1574158" cy="7803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342900" indent="-342900">
              <a:buAutoNum type="alphaUcPeriod"/>
            </a:pPr>
            <a:r>
              <a:rPr lang="en-US" sz="800" dirty="0">
                <a:solidFill>
                  <a:schemeClr val="tx1"/>
                </a:solidFill>
              </a:rPr>
              <a:t>Frontline workers in primary care (</a:t>
            </a:r>
            <a:r>
              <a:rPr lang="en-GB" sz="800" dirty="0">
                <a:solidFill>
                  <a:schemeClr val="tx1"/>
                </a:solidFill>
              </a:rPr>
              <a:t>e.g., GPs, social prescribers)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1DD6772F-E29E-455D-B356-739DF78B49BF}"/>
              </a:ext>
            </a:extLst>
          </p:cNvPr>
          <p:cNvSpPr/>
          <p:nvPr/>
        </p:nvSpPr>
        <p:spPr>
          <a:xfrm>
            <a:off x="10208358" y="4195792"/>
            <a:ext cx="1574158" cy="6936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342900" indent="-342900">
              <a:buFont typeface="+mj-lt"/>
              <a:buAutoNum type="alphaUcPeriod" startAt="2"/>
            </a:pPr>
            <a:r>
              <a:rPr lang="en-US" sz="800" dirty="0">
                <a:solidFill>
                  <a:schemeClr val="tx1"/>
                </a:solidFill>
              </a:rPr>
              <a:t>Frontline workers in secondary care (</a:t>
            </a:r>
            <a:r>
              <a:rPr lang="en-GB" sz="800" dirty="0">
                <a:solidFill>
                  <a:schemeClr val="tx1"/>
                </a:solidFill>
              </a:rPr>
              <a:t>e.g., mental health practitioners, clinicians) </a:t>
            </a:r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78BFA597-E463-4B3C-AE40-140B10CD085D}"/>
              </a:ext>
            </a:extLst>
          </p:cNvPr>
          <p:cNvSpPr/>
          <p:nvPr/>
        </p:nvSpPr>
        <p:spPr>
          <a:xfrm>
            <a:off x="10208358" y="4947758"/>
            <a:ext cx="1574158" cy="6936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342900" indent="-342900">
              <a:buFont typeface="+mj-lt"/>
              <a:buAutoNum type="alphaUcPeriod" startAt="3"/>
            </a:pPr>
            <a:r>
              <a:rPr lang="en-US" sz="800" dirty="0">
                <a:solidFill>
                  <a:schemeClr val="tx1"/>
                </a:solidFill>
              </a:rPr>
              <a:t>Managers across the Exemplar (</a:t>
            </a:r>
            <a:r>
              <a:rPr lang="en-GB" sz="800" dirty="0">
                <a:solidFill>
                  <a:schemeClr val="tx1"/>
                </a:solidFill>
              </a:rPr>
              <a:t>e.g., service managers, team managers) </a:t>
            </a:r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99D30C21-E34E-4602-8393-0BDD19296ADE}"/>
              </a:ext>
            </a:extLst>
          </p:cNvPr>
          <p:cNvSpPr/>
          <p:nvPr/>
        </p:nvSpPr>
        <p:spPr>
          <a:xfrm>
            <a:off x="10173626" y="5761006"/>
            <a:ext cx="1574158" cy="590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342900" indent="-342900">
              <a:buFont typeface="+mj-lt"/>
              <a:buAutoNum type="alphaUcPeriod" startAt="4"/>
            </a:pPr>
            <a:r>
              <a:rPr lang="en-GB" sz="800" dirty="0">
                <a:solidFill>
                  <a:schemeClr val="tx1"/>
                </a:solidFill>
              </a:rPr>
              <a:t>Senior Management (e.g., commissioners, directors) </a:t>
            </a:r>
          </a:p>
        </p:txBody>
      </p:sp>
      <p:cxnSp>
        <p:nvCxnSpPr>
          <p:cNvPr id="65" name="AutoShape 83">
            <a:extLst>
              <a:ext uri="{FF2B5EF4-FFF2-40B4-BE49-F238E27FC236}">
                <a16:creationId xmlns:a16="http://schemas.microsoft.com/office/drawing/2014/main" id="{E3E86860-A0C9-4AFA-A75D-C07D58630801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2135783" y="2044629"/>
            <a:ext cx="291360" cy="0"/>
          </a:xfrm>
          <a:prstGeom prst="straightConnector1">
            <a:avLst/>
          </a:prstGeom>
          <a:noFill/>
          <a:ln w="9525">
            <a:solidFill>
              <a:schemeClr val="bg2">
                <a:lumMod val="2500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D4D2D0"/>
                  </a:outerShdw>
                </a:effectLst>
              </a14:hiddenEffects>
            </a:ext>
          </a:extLst>
        </p:spPr>
      </p:cxnSp>
      <p:sp>
        <p:nvSpPr>
          <p:cNvPr id="82" name="Rectangle 81">
            <a:extLst>
              <a:ext uri="{FF2B5EF4-FFF2-40B4-BE49-F238E27FC236}">
                <a16:creationId xmlns:a16="http://schemas.microsoft.com/office/drawing/2014/main" id="{89C4CDFE-9D3F-4964-83C8-FB68BAB30AFE}"/>
              </a:ext>
            </a:extLst>
          </p:cNvPr>
          <p:cNvSpPr/>
          <p:nvPr/>
        </p:nvSpPr>
        <p:spPr>
          <a:xfrm>
            <a:off x="691137" y="2956806"/>
            <a:ext cx="3200337" cy="179411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9963F624-9EDF-4F4D-A0B6-99900D2A4F3B}"/>
              </a:ext>
            </a:extLst>
          </p:cNvPr>
          <p:cNvSpPr/>
          <p:nvPr/>
        </p:nvSpPr>
        <p:spPr>
          <a:xfrm>
            <a:off x="415239" y="2956806"/>
            <a:ext cx="177886" cy="179411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</a:rPr>
              <a:t>T1 – T2 (6 months)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5093F78A-C797-4A44-9561-D316B727A422}"/>
              </a:ext>
            </a:extLst>
          </p:cNvPr>
          <p:cNvSpPr/>
          <p:nvPr/>
        </p:nvSpPr>
        <p:spPr>
          <a:xfrm>
            <a:off x="691137" y="4917785"/>
            <a:ext cx="3200337" cy="179411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A1017B37-F2A4-45A4-AC95-8AF4D842B623}"/>
              </a:ext>
            </a:extLst>
          </p:cNvPr>
          <p:cNvSpPr/>
          <p:nvPr/>
        </p:nvSpPr>
        <p:spPr>
          <a:xfrm>
            <a:off x="408377" y="4927711"/>
            <a:ext cx="177886" cy="179411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</a:rPr>
              <a:t>T2 – T3 (6 months)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90" name="Rectangle 82">
            <a:extLst>
              <a:ext uri="{FF2B5EF4-FFF2-40B4-BE49-F238E27FC236}">
                <a16:creationId xmlns:a16="http://schemas.microsoft.com/office/drawing/2014/main" id="{C7B4CF3D-A817-424A-88A2-D780C77651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8906" y="4052120"/>
            <a:ext cx="472030" cy="1622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>
                <a:solidFill>
                  <a:srgbClr val="E1CF6C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omparison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102" name="Table 10">
            <a:extLst>
              <a:ext uri="{FF2B5EF4-FFF2-40B4-BE49-F238E27FC236}">
                <a16:creationId xmlns:a16="http://schemas.microsoft.com/office/drawing/2014/main" id="{E2E8AC2D-BB67-41C1-9637-53740F0DEB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7536895"/>
              </p:ext>
            </p:extLst>
          </p:nvPr>
        </p:nvGraphicFramePr>
        <p:xfrm>
          <a:off x="753894" y="5867922"/>
          <a:ext cx="1228481" cy="335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8481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282748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ervice activity in Primary Care (GPs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03" name="Table 10">
            <a:extLst>
              <a:ext uri="{FF2B5EF4-FFF2-40B4-BE49-F238E27FC236}">
                <a16:creationId xmlns:a16="http://schemas.microsoft.com/office/drawing/2014/main" id="{A89EDE5E-4B98-4BEB-AD0A-FEB571FCCC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5648681"/>
              </p:ext>
            </p:extLst>
          </p:nvPr>
        </p:nvGraphicFramePr>
        <p:xfrm>
          <a:off x="758883" y="6272785"/>
          <a:ext cx="1222016" cy="335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2016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257561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ervice activity in Social Car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sp>
        <p:nvSpPr>
          <p:cNvPr id="114" name="Rectangle 82">
            <a:extLst>
              <a:ext uri="{FF2B5EF4-FFF2-40B4-BE49-F238E27FC236}">
                <a16:creationId xmlns:a16="http://schemas.microsoft.com/office/drawing/2014/main" id="{6EE5D482-D204-4258-8885-AA778A0A78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3331" y="6083650"/>
            <a:ext cx="472030" cy="1622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>
                <a:solidFill>
                  <a:srgbClr val="E1CF6C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omparison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cxnSp>
        <p:nvCxnSpPr>
          <p:cNvPr id="119" name="AutoShape 83">
            <a:extLst>
              <a:ext uri="{FF2B5EF4-FFF2-40B4-BE49-F238E27FC236}">
                <a16:creationId xmlns:a16="http://schemas.microsoft.com/office/drawing/2014/main" id="{63803454-9FAD-4ECC-A8D2-72A2ED7D3A5F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136096" y="3925047"/>
            <a:ext cx="287567" cy="0"/>
          </a:xfrm>
          <a:prstGeom prst="straightConnector1">
            <a:avLst/>
          </a:prstGeom>
          <a:noFill/>
          <a:ln w="9525">
            <a:solidFill>
              <a:schemeClr val="bg2">
                <a:lumMod val="2500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D4D2D0"/>
                  </a:outerShdw>
                </a:effectLst>
              </a14:hiddenEffects>
            </a:ext>
          </a:extLst>
        </p:spPr>
      </p:cxnSp>
      <p:cxnSp>
        <p:nvCxnSpPr>
          <p:cNvPr id="120" name="AutoShape 83">
            <a:extLst>
              <a:ext uri="{FF2B5EF4-FFF2-40B4-BE49-F238E27FC236}">
                <a16:creationId xmlns:a16="http://schemas.microsoft.com/office/drawing/2014/main" id="{95D6D729-FB70-4DBA-8301-499B26993BCD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2132303" y="4017538"/>
            <a:ext cx="291360" cy="0"/>
          </a:xfrm>
          <a:prstGeom prst="straightConnector1">
            <a:avLst/>
          </a:prstGeom>
          <a:noFill/>
          <a:ln w="9525">
            <a:solidFill>
              <a:schemeClr val="bg2">
                <a:lumMod val="2500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D4D2D0"/>
                  </a:outerShdw>
                </a:effectLst>
              </a14:hiddenEffects>
            </a:ext>
          </a:extLst>
        </p:spPr>
      </p:cxnSp>
      <p:cxnSp>
        <p:nvCxnSpPr>
          <p:cNvPr id="121" name="AutoShape 83">
            <a:extLst>
              <a:ext uri="{FF2B5EF4-FFF2-40B4-BE49-F238E27FC236}">
                <a16:creationId xmlns:a16="http://schemas.microsoft.com/office/drawing/2014/main" id="{A6812F36-DBE1-4292-A4FE-190101B48E1C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2145016" y="5946009"/>
            <a:ext cx="302711" cy="4486"/>
          </a:xfrm>
          <a:prstGeom prst="straightConnector1">
            <a:avLst/>
          </a:prstGeom>
          <a:noFill/>
          <a:ln w="9525">
            <a:solidFill>
              <a:schemeClr val="bg2">
                <a:lumMod val="2500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D4D2D0"/>
                  </a:outerShdw>
                </a:effectLst>
              </a14:hiddenEffects>
            </a:ext>
          </a:extLst>
        </p:spPr>
      </p:cxnSp>
      <p:cxnSp>
        <p:nvCxnSpPr>
          <p:cNvPr id="122" name="AutoShape 83">
            <a:extLst>
              <a:ext uri="{FF2B5EF4-FFF2-40B4-BE49-F238E27FC236}">
                <a16:creationId xmlns:a16="http://schemas.microsoft.com/office/drawing/2014/main" id="{B4046B0B-F108-4E6E-B8DA-6B8CF94AAF25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2135499" y="6044318"/>
            <a:ext cx="291360" cy="0"/>
          </a:xfrm>
          <a:prstGeom prst="straightConnector1">
            <a:avLst/>
          </a:prstGeom>
          <a:noFill/>
          <a:ln w="9525">
            <a:solidFill>
              <a:schemeClr val="bg2">
                <a:lumMod val="2500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D4D2D0"/>
                  </a:outerShdw>
                </a:effectLst>
              </a14:hiddenEffects>
            </a:ext>
          </a:extLst>
        </p:spPr>
      </p:cxnSp>
      <p:sp>
        <p:nvSpPr>
          <p:cNvPr id="123" name="Rectangle 122">
            <a:extLst>
              <a:ext uri="{FF2B5EF4-FFF2-40B4-BE49-F238E27FC236}">
                <a16:creationId xmlns:a16="http://schemas.microsoft.com/office/drawing/2014/main" id="{EAD1E939-B87B-490A-8CF5-607859CE42E2}"/>
              </a:ext>
            </a:extLst>
          </p:cNvPr>
          <p:cNvSpPr/>
          <p:nvPr/>
        </p:nvSpPr>
        <p:spPr>
          <a:xfrm>
            <a:off x="4816248" y="2968615"/>
            <a:ext cx="3265595" cy="174086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dirty="0"/>
          </a:p>
        </p:txBody>
      </p:sp>
      <p:sp>
        <p:nvSpPr>
          <p:cNvPr id="124" name="Rectangle 82">
            <a:extLst>
              <a:ext uri="{FF2B5EF4-FFF2-40B4-BE49-F238E27FC236}">
                <a16:creationId xmlns:a16="http://schemas.microsoft.com/office/drawing/2014/main" id="{F704D7F9-16C2-45DA-B462-A4F0C5A34F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82377" y="5973840"/>
            <a:ext cx="472030" cy="1622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>
                <a:solidFill>
                  <a:srgbClr val="E1CF6C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omparison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cxnSp>
        <p:nvCxnSpPr>
          <p:cNvPr id="125" name="AutoShape 83">
            <a:extLst>
              <a:ext uri="{FF2B5EF4-FFF2-40B4-BE49-F238E27FC236}">
                <a16:creationId xmlns:a16="http://schemas.microsoft.com/office/drawing/2014/main" id="{A16BE9E5-4FFC-4857-A797-5DA84A6C89EE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6291043" y="5817187"/>
            <a:ext cx="302711" cy="4486"/>
          </a:xfrm>
          <a:prstGeom prst="straightConnector1">
            <a:avLst/>
          </a:prstGeom>
          <a:noFill/>
          <a:ln w="9525">
            <a:solidFill>
              <a:schemeClr val="bg2">
                <a:lumMod val="2500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D4D2D0"/>
                  </a:outerShdw>
                </a:effectLst>
              </a14:hiddenEffects>
            </a:ext>
          </a:extLst>
        </p:spPr>
      </p:cxnSp>
      <p:cxnSp>
        <p:nvCxnSpPr>
          <p:cNvPr id="126" name="AutoShape 83">
            <a:extLst>
              <a:ext uri="{FF2B5EF4-FFF2-40B4-BE49-F238E27FC236}">
                <a16:creationId xmlns:a16="http://schemas.microsoft.com/office/drawing/2014/main" id="{03BD5720-6268-467C-B380-663C827273A8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6281526" y="5915496"/>
            <a:ext cx="291360" cy="0"/>
          </a:xfrm>
          <a:prstGeom prst="straightConnector1">
            <a:avLst/>
          </a:prstGeom>
          <a:noFill/>
          <a:ln w="9525">
            <a:solidFill>
              <a:schemeClr val="bg2">
                <a:lumMod val="2500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D4D2D0"/>
                  </a:outerShdw>
                </a:effectLst>
              </a14:hiddenEffects>
            </a:ext>
          </a:extLst>
        </p:spPr>
      </p:cxnSp>
      <p:sp>
        <p:nvSpPr>
          <p:cNvPr id="127" name="Rectangle 126">
            <a:extLst>
              <a:ext uri="{FF2B5EF4-FFF2-40B4-BE49-F238E27FC236}">
                <a16:creationId xmlns:a16="http://schemas.microsoft.com/office/drawing/2014/main" id="{7A6C82E2-174C-4328-B4BD-829669525FB2}"/>
              </a:ext>
            </a:extLst>
          </p:cNvPr>
          <p:cNvSpPr/>
          <p:nvPr/>
        </p:nvSpPr>
        <p:spPr>
          <a:xfrm>
            <a:off x="9936725" y="2466971"/>
            <a:ext cx="1079450" cy="32302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</a:rPr>
              <a:t>Interview Guide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128" name="Arrow: Down 127">
            <a:extLst>
              <a:ext uri="{FF2B5EF4-FFF2-40B4-BE49-F238E27FC236}">
                <a16:creationId xmlns:a16="http://schemas.microsoft.com/office/drawing/2014/main" id="{346E2E15-85C8-40E6-930B-044B1200FF2C}"/>
              </a:ext>
            </a:extLst>
          </p:cNvPr>
          <p:cNvSpPr/>
          <p:nvPr/>
        </p:nvSpPr>
        <p:spPr>
          <a:xfrm>
            <a:off x="10417801" y="1994867"/>
            <a:ext cx="117301" cy="396821"/>
          </a:xfrm>
          <a:prstGeom prst="downArrow">
            <a:avLst>
              <a:gd name="adj1" fmla="val 27497"/>
              <a:gd name="adj2" fmla="val 50000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dirty="0"/>
          </a:p>
        </p:txBody>
      </p:sp>
      <p:sp>
        <p:nvSpPr>
          <p:cNvPr id="135" name="Arrow: Down 134">
            <a:extLst>
              <a:ext uri="{FF2B5EF4-FFF2-40B4-BE49-F238E27FC236}">
                <a16:creationId xmlns:a16="http://schemas.microsoft.com/office/drawing/2014/main" id="{96124BE1-3588-49C6-8E45-33ACCE111E0E}"/>
              </a:ext>
            </a:extLst>
          </p:cNvPr>
          <p:cNvSpPr/>
          <p:nvPr/>
        </p:nvSpPr>
        <p:spPr>
          <a:xfrm>
            <a:off x="10417800" y="2948612"/>
            <a:ext cx="117301" cy="396821"/>
          </a:xfrm>
          <a:prstGeom prst="downArrow">
            <a:avLst>
              <a:gd name="adj1" fmla="val 27497"/>
              <a:gd name="adj2" fmla="val 50000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dirty="0"/>
          </a:p>
        </p:txBody>
      </p:sp>
      <p:graphicFrame>
        <p:nvGraphicFramePr>
          <p:cNvPr id="137" name="Table 10">
            <a:extLst>
              <a:ext uri="{FF2B5EF4-FFF2-40B4-BE49-F238E27FC236}">
                <a16:creationId xmlns:a16="http://schemas.microsoft.com/office/drawing/2014/main" id="{7EC637C9-85CF-42B6-93E2-F61A8E6BD2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8544133"/>
              </p:ext>
            </p:extLst>
          </p:nvPr>
        </p:nvGraphicFramePr>
        <p:xfrm>
          <a:off x="6752111" y="5534928"/>
          <a:ext cx="1238823" cy="40644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406447"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chemeClr val="tx1"/>
                          </a:solidFill>
                        </a:rPr>
                        <a:t>Primary Care Mental Health Services</a:t>
                      </a:r>
                      <a:endParaRPr lang="en-GB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38" name="Table 10">
            <a:extLst>
              <a:ext uri="{FF2B5EF4-FFF2-40B4-BE49-F238E27FC236}">
                <a16:creationId xmlns:a16="http://schemas.microsoft.com/office/drawing/2014/main" id="{6B3DC395-476E-430A-A3FE-97328D0034D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4534338"/>
              </p:ext>
            </p:extLst>
          </p:nvPr>
        </p:nvGraphicFramePr>
        <p:xfrm>
          <a:off x="6752111" y="6073388"/>
          <a:ext cx="1238823" cy="49776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497766"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chemeClr val="tx1"/>
                          </a:solidFill>
                        </a:rPr>
                        <a:t>Secondary Care Mental Health services </a:t>
                      </a:r>
                      <a:endParaRPr lang="en-GB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sp>
        <p:nvSpPr>
          <p:cNvPr id="139" name="Rectangle 138">
            <a:extLst>
              <a:ext uri="{FF2B5EF4-FFF2-40B4-BE49-F238E27FC236}">
                <a16:creationId xmlns:a16="http://schemas.microsoft.com/office/drawing/2014/main" id="{19B9F326-FE60-4F60-8F5A-2DBC6D7C8CB3}"/>
              </a:ext>
            </a:extLst>
          </p:cNvPr>
          <p:cNvSpPr/>
          <p:nvPr/>
        </p:nvSpPr>
        <p:spPr>
          <a:xfrm>
            <a:off x="4916790" y="3117103"/>
            <a:ext cx="1229300" cy="36537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</a:rPr>
              <a:t>Intervention Group: Peterborough</a:t>
            </a:r>
            <a:endParaRPr lang="en-GB" sz="800" dirty="0">
              <a:solidFill>
                <a:schemeClr val="tx1"/>
              </a:solidFill>
            </a:endParaRPr>
          </a:p>
        </p:txBody>
      </p:sp>
      <p:graphicFrame>
        <p:nvGraphicFramePr>
          <p:cNvPr id="140" name="Table 10">
            <a:extLst>
              <a:ext uri="{FF2B5EF4-FFF2-40B4-BE49-F238E27FC236}">
                <a16:creationId xmlns:a16="http://schemas.microsoft.com/office/drawing/2014/main" id="{548A534F-B7AC-4E49-A008-4B00C73FD7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8322267"/>
              </p:ext>
            </p:extLst>
          </p:nvPr>
        </p:nvGraphicFramePr>
        <p:xfrm>
          <a:off x="4913586" y="3558560"/>
          <a:ext cx="1238823" cy="40644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406447"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chemeClr val="tx1"/>
                          </a:solidFill>
                        </a:rPr>
                        <a:t>Primary Care Mental Health Services</a:t>
                      </a:r>
                      <a:endParaRPr lang="en-GB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41" name="Table 10">
            <a:extLst>
              <a:ext uri="{FF2B5EF4-FFF2-40B4-BE49-F238E27FC236}">
                <a16:creationId xmlns:a16="http://schemas.microsoft.com/office/drawing/2014/main" id="{94C6AEB8-4E95-40FF-919B-9CF3039DB9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7113522"/>
              </p:ext>
            </p:extLst>
          </p:nvPr>
        </p:nvGraphicFramePr>
        <p:xfrm>
          <a:off x="4916892" y="4107726"/>
          <a:ext cx="1238823" cy="47620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476203"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chemeClr val="tx1"/>
                          </a:solidFill>
                        </a:rPr>
                        <a:t>Secondary Care Mental Health services </a:t>
                      </a:r>
                      <a:endParaRPr lang="en-GB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sp>
        <p:nvSpPr>
          <p:cNvPr id="142" name="Rectangle 82">
            <a:extLst>
              <a:ext uri="{FF2B5EF4-FFF2-40B4-BE49-F238E27FC236}">
                <a16:creationId xmlns:a16="http://schemas.microsoft.com/office/drawing/2014/main" id="{7DAAD5C4-B1F3-418F-A715-1FE3D06AB7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95913" y="4005152"/>
            <a:ext cx="472030" cy="1622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>
                <a:solidFill>
                  <a:srgbClr val="E1CF6C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omparison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cxnSp>
        <p:nvCxnSpPr>
          <p:cNvPr id="143" name="AutoShape 83">
            <a:extLst>
              <a:ext uri="{FF2B5EF4-FFF2-40B4-BE49-F238E27FC236}">
                <a16:creationId xmlns:a16="http://schemas.microsoft.com/office/drawing/2014/main" id="{79619226-09A7-42E1-AD6E-54B0A96B0F19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6304579" y="3848499"/>
            <a:ext cx="302711" cy="4486"/>
          </a:xfrm>
          <a:prstGeom prst="straightConnector1">
            <a:avLst/>
          </a:prstGeom>
          <a:noFill/>
          <a:ln w="9525">
            <a:solidFill>
              <a:schemeClr val="bg2">
                <a:lumMod val="2500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D4D2D0"/>
                  </a:outerShdw>
                </a:effectLst>
              </a14:hiddenEffects>
            </a:ext>
          </a:extLst>
        </p:spPr>
      </p:cxnSp>
      <p:cxnSp>
        <p:nvCxnSpPr>
          <p:cNvPr id="144" name="AutoShape 83">
            <a:extLst>
              <a:ext uri="{FF2B5EF4-FFF2-40B4-BE49-F238E27FC236}">
                <a16:creationId xmlns:a16="http://schemas.microsoft.com/office/drawing/2014/main" id="{D4C13D0E-F41A-434D-BD47-172ACB7D7505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6295062" y="3946808"/>
            <a:ext cx="291360" cy="0"/>
          </a:xfrm>
          <a:prstGeom prst="straightConnector1">
            <a:avLst/>
          </a:prstGeom>
          <a:noFill/>
          <a:ln w="9525">
            <a:solidFill>
              <a:schemeClr val="bg2">
                <a:lumMod val="2500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D4D2D0"/>
                  </a:outerShdw>
                </a:effectLst>
              </a14:hiddenEffects>
            </a:ext>
          </a:extLst>
        </p:spPr>
      </p:cxnSp>
      <p:sp>
        <p:nvSpPr>
          <p:cNvPr id="145" name="Rectangle 144">
            <a:extLst>
              <a:ext uri="{FF2B5EF4-FFF2-40B4-BE49-F238E27FC236}">
                <a16:creationId xmlns:a16="http://schemas.microsoft.com/office/drawing/2014/main" id="{72254D0E-B4B3-4ACA-B98B-EE9BD81FD05C}"/>
              </a:ext>
            </a:extLst>
          </p:cNvPr>
          <p:cNvSpPr/>
          <p:nvPr/>
        </p:nvSpPr>
        <p:spPr>
          <a:xfrm>
            <a:off x="6752111" y="3115096"/>
            <a:ext cx="1229300" cy="36537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</a:rPr>
              <a:t>Comparator Group: Fenland</a:t>
            </a:r>
            <a:endParaRPr lang="en-GB" sz="800" dirty="0">
              <a:solidFill>
                <a:schemeClr val="tx1"/>
              </a:solidFill>
            </a:endParaRPr>
          </a:p>
        </p:txBody>
      </p:sp>
      <p:graphicFrame>
        <p:nvGraphicFramePr>
          <p:cNvPr id="146" name="Table 10">
            <a:extLst>
              <a:ext uri="{FF2B5EF4-FFF2-40B4-BE49-F238E27FC236}">
                <a16:creationId xmlns:a16="http://schemas.microsoft.com/office/drawing/2014/main" id="{846D2762-4779-4AD5-A1FF-7565F8EAC8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3652241"/>
              </p:ext>
            </p:extLst>
          </p:nvPr>
        </p:nvGraphicFramePr>
        <p:xfrm>
          <a:off x="6748907" y="3556553"/>
          <a:ext cx="1238823" cy="40644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406447"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chemeClr val="tx1"/>
                          </a:solidFill>
                        </a:rPr>
                        <a:t>Primary Care Mental Health Services</a:t>
                      </a:r>
                      <a:endParaRPr lang="en-GB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47" name="Table 10">
            <a:extLst>
              <a:ext uri="{FF2B5EF4-FFF2-40B4-BE49-F238E27FC236}">
                <a16:creationId xmlns:a16="http://schemas.microsoft.com/office/drawing/2014/main" id="{276CF97B-CA00-4578-93B4-1C2D40A9CA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3833337"/>
              </p:ext>
            </p:extLst>
          </p:nvPr>
        </p:nvGraphicFramePr>
        <p:xfrm>
          <a:off x="6752111" y="4082758"/>
          <a:ext cx="1238823" cy="49776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497766"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chemeClr val="tx1"/>
                          </a:solidFill>
                        </a:rPr>
                        <a:t>Secondary Care Mental Health services </a:t>
                      </a:r>
                      <a:endParaRPr lang="en-GB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sp>
        <p:nvSpPr>
          <p:cNvPr id="91" name="Rectangle 90">
            <a:extLst>
              <a:ext uri="{FF2B5EF4-FFF2-40B4-BE49-F238E27FC236}">
                <a16:creationId xmlns:a16="http://schemas.microsoft.com/office/drawing/2014/main" id="{14C1FCAC-06E0-40B2-94E6-288EB9DDBD2E}"/>
              </a:ext>
            </a:extLst>
          </p:cNvPr>
          <p:cNvSpPr/>
          <p:nvPr/>
        </p:nvSpPr>
        <p:spPr>
          <a:xfrm>
            <a:off x="764365" y="5035586"/>
            <a:ext cx="1229300" cy="36537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</a:rPr>
              <a:t>Intervention Group: Peterborough</a:t>
            </a:r>
            <a:endParaRPr lang="en-GB" sz="800" dirty="0">
              <a:solidFill>
                <a:schemeClr val="tx1"/>
              </a:solidFill>
            </a:endParaRPr>
          </a:p>
        </p:txBody>
      </p:sp>
      <p:graphicFrame>
        <p:nvGraphicFramePr>
          <p:cNvPr id="150" name="Table 10">
            <a:extLst>
              <a:ext uri="{FF2B5EF4-FFF2-40B4-BE49-F238E27FC236}">
                <a16:creationId xmlns:a16="http://schemas.microsoft.com/office/drawing/2014/main" id="{7C5AC41B-EADA-4139-8989-915A4C3EC5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1297157"/>
              </p:ext>
            </p:extLst>
          </p:nvPr>
        </p:nvGraphicFramePr>
        <p:xfrm>
          <a:off x="757039" y="5458725"/>
          <a:ext cx="1238823" cy="36537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365374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ysClr val="windowText" lastClr="000000"/>
                          </a:solidFill>
                        </a:rPr>
                        <a:t>Service activity in Mental Health Trus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61" name="Table 10">
            <a:extLst>
              <a:ext uri="{FF2B5EF4-FFF2-40B4-BE49-F238E27FC236}">
                <a16:creationId xmlns:a16="http://schemas.microsoft.com/office/drawing/2014/main" id="{81FAF795-B230-4FFE-BBF7-9ABCF821F7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8519142"/>
              </p:ext>
            </p:extLst>
          </p:nvPr>
        </p:nvGraphicFramePr>
        <p:xfrm>
          <a:off x="2586465" y="5848639"/>
          <a:ext cx="1225514" cy="335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5514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282748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ervice activity in Primary Care </a:t>
                      </a:r>
                      <a:r>
                        <a:rPr kumimoji="0" lang="en-US" altLang="en-US" sz="800" b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(GPs)</a:t>
                      </a:r>
                      <a:endParaRPr kumimoji="0" lang="en-US" altLang="en-US" sz="800" b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62" name="Table 10">
            <a:extLst>
              <a:ext uri="{FF2B5EF4-FFF2-40B4-BE49-F238E27FC236}">
                <a16:creationId xmlns:a16="http://schemas.microsoft.com/office/drawing/2014/main" id="{129281EE-BC87-43F8-B125-5CFF278D3B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5819546"/>
              </p:ext>
            </p:extLst>
          </p:nvPr>
        </p:nvGraphicFramePr>
        <p:xfrm>
          <a:off x="2573258" y="6268490"/>
          <a:ext cx="1222016" cy="335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2016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257561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ervice activity in Social Car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sp>
        <p:nvSpPr>
          <p:cNvPr id="163" name="Rectangle 162">
            <a:extLst>
              <a:ext uri="{FF2B5EF4-FFF2-40B4-BE49-F238E27FC236}">
                <a16:creationId xmlns:a16="http://schemas.microsoft.com/office/drawing/2014/main" id="{30A60016-784E-4280-A29D-C967C24F9716}"/>
              </a:ext>
            </a:extLst>
          </p:cNvPr>
          <p:cNvSpPr/>
          <p:nvPr/>
        </p:nvSpPr>
        <p:spPr>
          <a:xfrm>
            <a:off x="2575553" y="5035586"/>
            <a:ext cx="1229300" cy="36537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</a:rPr>
              <a:t>Comparator Group: Fenland</a:t>
            </a:r>
            <a:endParaRPr lang="en-GB" sz="800" dirty="0">
              <a:solidFill>
                <a:schemeClr val="tx1"/>
              </a:solidFill>
            </a:endParaRPr>
          </a:p>
        </p:txBody>
      </p:sp>
      <p:graphicFrame>
        <p:nvGraphicFramePr>
          <p:cNvPr id="164" name="Table 10">
            <a:extLst>
              <a:ext uri="{FF2B5EF4-FFF2-40B4-BE49-F238E27FC236}">
                <a16:creationId xmlns:a16="http://schemas.microsoft.com/office/drawing/2014/main" id="{F8A374AF-D40F-406C-A424-65532A3EF7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4462610"/>
              </p:ext>
            </p:extLst>
          </p:nvPr>
        </p:nvGraphicFramePr>
        <p:xfrm>
          <a:off x="2575553" y="5458725"/>
          <a:ext cx="1238823" cy="36537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365374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ysClr val="windowText" lastClr="000000"/>
                          </a:solidFill>
                        </a:rPr>
                        <a:t>Service activity in Mental Health Trus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65" name="Table 10">
            <a:extLst>
              <a:ext uri="{FF2B5EF4-FFF2-40B4-BE49-F238E27FC236}">
                <a16:creationId xmlns:a16="http://schemas.microsoft.com/office/drawing/2014/main" id="{D34707CB-C251-44A1-A0E8-C49D416AE1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754916"/>
              </p:ext>
            </p:extLst>
          </p:nvPr>
        </p:nvGraphicFramePr>
        <p:xfrm>
          <a:off x="764365" y="1944742"/>
          <a:ext cx="1228481" cy="335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8481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282748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ervice activity in Primary Care (GPs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66" name="Table 10">
            <a:extLst>
              <a:ext uri="{FF2B5EF4-FFF2-40B4-BE49-F238E27FC236}">
                <a16:creationId xmlns:a16="http://schemas.microsoft.com/office/drawing/2014/main" id="{67B08B1B-2759-42B1-B497-5AAEF37D91F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1677632"/>
              </p:ext>
            </p:extLst>
          </p:nvPr>
        </p:nvGraphicFramePr>
        <p:xfrm>
          <a:off x="769354" y="2349605"/>
          <a:ext cx="1222016" cy="335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2016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257561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ervice activity in Social Car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sp>
        <p:nvSpPr>
          <p:cNvPr id="167" name="Rectangle 166">
            <a:extLst>
              <a:ext uri="{FF2B5EF4-FFF2-40B4-BE49-F238E27FC236}">
                <a16:creationId xmlns:a16="http://schemas.microsoft.com/office/drawing/2014/main" id="{F3559A5B-CCCC-4E6F-9569-C58312E74F98}"/>
              </a:ext>
            </a:extLst>
          </p:cNvPr>
          <p:cNvSpPr/>
          <p:nvPr/>
        </p:nvSpPr>
        <p:spPr>
          <a:xfrm>
            <a:off x="774836" y="1112406"/>
            <a:ext cx="1229300" cy="36537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</a:rPr>
              <a:t>Intervention Group: Peterborough</a:t>
            </a:r>
            <a:endParaRPr lang="en-GB" sz="800" dirty="0">
              <a:solidFill>
                <a:schemeClr val="tx1"/>
              </a:solidFill>
            </a:endParaRPr>
          </a:p>
        </p:txBody>
      </p:sp>
      <p:graphicFrame>
        <p:nvGraphicFramePr>
          <p:cNvPr id="168" name="Table 10">
            <a:extLst>
              <a:ext uri="{FF2B5EF4-FFF2-40B4-BE49-F238E27FC236}">
                <a16:creationId xmlns:a16="http://schemas.microsoft.com/office/drawing/2014/main" id="{9ED6D63C-6628-4172-8B5C-93FFB58C59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5032016"/>
              </p:ext>
            </p:extLst>
          </p:nvPr>
        </p:nvGraphicFramePr>
        <p:xfrm>
          <a:off x="767510" y="1535545"/>
          <a:ext cx="1238823" cy="36537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365374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ysClr val="windowText" lastClr="000000"/>
                          </a:solidFill>
                        </a:rPr>
                        <a:t>Service activity in Mental Health Trus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69" name="Table 10">
            <a:extLst>
              <a:ext uri="{FF2B5EF4-FFF2-40B4-BE49-F238E27FC236}">
                <a16:creationId xmlns:a16="http://schemas.microsoft.com/office/drawing/2014/main" id="{79C50D74-066A-473E-A1D3-66F494EF49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8445722"/>
              </p:ext>
            </p:extLst>
          </p:nvPr>
        </p:nvGraphicFramePr>
        <p:xfrm>
          <a:off x="2596936" y="1925459"/>
          <a:ext cx="1225514" cy="335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5514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282748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ervice activity in Primary Care (GPs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70" name="Table 10">
            <a:extLst>
              <a:ext uri="{FF2B5EF4-FFF2-40B4-BE49-F238E27FC236}">
                <a16:creationId xmlns:a16="http://schemas.microsoft.com/office/drawing/2014/main" id="{D6937CFA-0F81-401E-9A6B-8DED44C09B6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2692217"/>
              </p:ext>
            </p:extLst>
          </p:nvPr>
        </p:nvGraphicFramePr>
        <p:xfrm>
          <a:off x="2587668" y="2349605"/>
          <a:ext cx="1222016" cy="335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2016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257561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ervice activity in Social Car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sp>
        <p:nvSpPr>
          <p:cNvPr id="171" name="Rectangle 170">
            <a:extLst>
              <a:ext uri="{FF2B5EF4-FFF2-40B4-BE49-F238E27FC236}">
                <a16:creationId xmlns:a16="http://schemas.microsoft.com/office/drawing/2014/main" id="{3509E4AD-9272-405F-AAA2-A9FC51A12ECD}"/>
              </a:ext>
            </a:extLst>
          </p:cNvPr>
          <p:cNvSpPr/>
          <p:nvPr/>
        </p:nvSpPr>
        <p:spPr>
          <a:xfrm>
            <a:off x="2586024" y="1112406"/>
            <a:ext cx="1229300" cy="36537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</a:rPr>
              <a:t>Comparator Group: Fenland</a:t>
            </a:r>
            <a:endParaRPr lang="en-GB" sz="800" dirty="0">
              <a:solidFill>
                <a:schemeClr val="tx1"/>
              </a:solidFill>
            </a:endParaRPr>
          </a:p>
        </p:txBody>
      </p:sp>
      <p:graphicFrame>
        <p:nvGraphicFramePr>
          <p:cNvPr id="172" name="Table 10">
            <a:extLst>
              <a:ext uri="{FF2B5EF4-FFF2-40B4-BE49-F238E27FC236}">
                <a16:creationId xmlns:a16="http://schemas.microsoft.com/office/drawing/2014/main" id="{006F4E67-0E01-4FAF-916E-0EECB3EAA4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1852704"/>
              </p:ext>
            </p:extLst>
          </p:nvPr>
        </p:nvGraphicFramePr>
        <p:xfrm>
          <a:off x="2586024" y="1535545"/>
          <a:ext cx="1238823" cy="36537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365374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ysClr val="windowText" lastClr="000000"/>
                          </a:solidFill>
                        </a:rPr>
                        <a:t>Service activity in Mental Health Trus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73" name="Table 10">
            <a:extLst>
              <a:ext uri="{FF2B5EF4-FFF2-40B4-BE49-F238E27FC236}">
                <a16:creationId xmlns:a16="http://schemas.microsoft.com/office/drawing/2014/main" id="{B2179833-D901-4ADD-8C59-B9252D1EDD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6355868"/>
              </p:ext>
            </p:extLst>
          </p:nvPr>
        </p:nvGraphicFramePr>
        <p:xfrm>
          <a:off x="751599" y="3905348"/>
          <a:ext cx="1228481" cy="335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8481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282748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ervice activity in Primary Care (GPs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74" name="Table 10">
            <a:extLst>
              <a:ext uri="{FF2B5EF4-FFF2-40B4-BE49-F238E27FC236}">
                <a16:creationId xmlns:a16="http://schemas.microsoft.com/office/drawing/2014/main" id="{EF5B76B1-4714-4547-A5AA-1ED40494E6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5003774"/>
              </p:ext>
            </p:extLst>
          </p:nvPr>
        </p:nvGraphicFramePr>
        <p:xfrm>
          <a:off x="756588" y="4310211"/>
          <a:ext cx="1222016" cy="335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2016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257561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ervice activity in Social Car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sp>
        <p:nvSpPr>
          <p:cNvPr id="175" name="Rectangle 174">
            <a:extLst>
              <a:ext uri="{FF2B5EF4-FFF2-40B4-BE49-F238E27FC236}">
                <a16:creationId xmlns:a16="http://schemas.microsoft.com/office/drawing/2014/main" id="{04F1B5A5-E196-4E3B-B355-12DE419CDAF1}"/>
              </a:ext>
            </a:extLst>
          </p:cNvPr>
          <p:cNvSpPr/>
          <p:nvPr/>
        </p:nvSpPr>
        <p:spPr>
          <a:xfrm>
            <a:off x="762070" y="3073012"/>
            <a:ext cx="1229300" cy="36537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</a:rPr>
              <a:t>Intervention Group: Peterborough</a:t>
            </a:r>
            <a:endParaRPr lang="en-GB" sz="800" dirty="0">
              <a:solidFill>
                <a:schemeClr val="tx1"/>
              </a:solidFill>
            </a:endParaRPr>
          </a:p>
        </p:txBody>
      </p:sp>
      <p:graphicFrame>
        <p:nvGraphicFramePr>
          <p:cNvPr id="176" name="Table 10">
            <a:extLst>
              <a:ext uri="{FF2B5EF4-FFF2-40B4-BE49-F238E27FC236}">
                <a16:creationId xmlns:a16="http://schemas.microsoft.com/office/drawing/2014/main" id="{76375B1C-7919-40EB-A3EB-560D2C4A9E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9189995"/>
              </p:ext>
            </p:extLst>
          </p:nvPr>
        </p:nvGraphicFramePr>
        <p:xfrm>
          <a:off x="754744" y="3496151"/>
          <a:ext cx="1238823" cy="36537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365374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ysClr val="windowText" lastClr="000000"/>
                          </a:solidFill>
                        </a:rPr>
                        <a:t>Service activity in Mental Health Trus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77" name="Table 10">
            <a:extLst>
              <a:ext uri="{FF2B5EF4-FFF2-40B4-BE49-F238E27FC236}">
                <a16:creationId xmlns:a16="http://schemas.microsoft.com/office/drawing/2014/main" id="{B538D807-000E-4905-8929-84CBD0C7D0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2803154"/>
              </p:ext>
            </p:extLst>
          </p:nvPr>
        </p:nvGraphicFramePr>
        <p:xfrm>
          <a:off x="2584170" y="3886065"/>
          <a:ext cx="1225514" cy="335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5514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282748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ervice activity in Primary Care (GPs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graphicFrame>
        <p:nvGraphicFramePr>
          <p:cNvPr id="178" name="Table 10">
            <a:extLst>
              <a:ext uri="{FF2B5EF4-FFF2-40B4-BE49-F238E27FC236}">
                <a16:creationId xmlns:a16="http://schemas.microsoft.com/office/drawing/2014/main" id="{63D341E5-B0BE-49A7-86B4-F1D0FC1426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0056146"/>
              </p:ext>
            </p:extLst>
          </p:nvPr>
        </p:nvGraphicFramePr>
        <p:xfrm>
          <a:off x="2573327" y="4310211"/>
          <a:ext cx="1222016" cy="335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2016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257561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ervice activity in Social Car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sp>
        <p:nvSpPr>
          <p:cNvPr id="179" name="Rectangle 178">
            <a:extLst>
              <a:ext uri="{FF2B5EF4-FFF2-40B4-BE49-F238E27FC236}">
                <a16:creationId xmlns:a16="http://schemas.microsoft.com/office/drawing/2014/main" id="{F5137748-FDCD-4C37-9732-BB20E20DBAC8}"/>
              </a:ext>
            </a:extLst>
          </p:cNvPr>
          <p:cNvSpPr/>
          <p:nvPr/>
        </p:nvSpPr>
        <p:spPr>
          <a:xfrm>
            <a:off x="2573258" y="3073012"/>
            <a:ext cx="1229300" cy="36537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</a:rPr>
              <a:t>Comparator Group: Fenland</a:t>
            </a:r>
            <a:endParaRPr lang="en-GB" sz="800" dirty="0">
              <a:solidFill>
                <a:schemeClr val="tx1"/>
              </a:solidFill>
            </a:endParaRPr>
          </a:p>
        </p:txBody>
      </p:sp>
      <p:graphicFrame>
        <p:nvGraphicFramePr>
          <p:cNvPr id="180" name="Table 10">
            <a:extLst>
              <a:ext uri="{FF2B5EF4-FFF2-40B4-BE49-F238E27FC236}">
                <a16:creationId xmlns:a16="http://schemas.microsoft.com/office/drawing/2014/main" id="{B5D5FDBE-F7C6-4449-B2CE-C866D4004C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7420630"/>
              </p:ext>
            </p:extLst>
          </p:nvPr>
        </p:nvGraphicFramePr>
        <p:xfrm>
          <a:off x="2573258" y="3496151"/>
          <a:ext cx="1238823" cy="36537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38823">
                  <a:extLst>
                    <a:ext uri="{9D8B030D-6E8A-4147-A177-3AD203B41FA5}">
                      <a16:colId xmlns:a16="http://schemas.microsoft.com/office/drawing/2014/main" val="4119885486"/>
                    </a:ext>
                  </a:extLst>
                </a:gridCol>
              </a:tblGrid>
              <a:tr h="365374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ysClr val="windowText" lastClr="000000"/>
                          </a:solidFill>
                        </a:rPr>
                        <a:t>Service activity in Mental Health Trus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4294533"/>
                  </a:ext>
                </a:extLst>
              </a:tr>
            </a:tbl>
          </a:graphicData>
        </a:graphic>
      </p:graphicFrame>
      <p:sp>
        <p:nvSpPr>
          <p:cNvPr id="80" name="Rectangle 79">
            <a:extLst>
              <a:ext uri="{FF2B5EF4-FFF2-40B4-BE49-F238E27FC236}">
                <a16:creationId xmlns:a16="http://schemas.microsoft.com/office/drawing/2014/main" id="{7F947A95-3ECE-4C14-ABA3-E4FE22E48F8C}"/>
              </a:ext>
            </a:extLst>
          </p:cNvPr>
          <p:cNvSpPr/>
          <p:nvPr/>
        </p:nvSpPr>
        <p:spPr>
          <a:xfrm>
            <a:off x="4903254" y="5039550"/>
            <a:ext cx="1229300" cy="36537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</a:rPr>
              <a:t>Intervention Group: Peterborough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0A82944E-ACE2-4601-B516-11E7EF5B2ECF}"/>
              </a:ext>
            </a:extLst>
          </p:cNvPr>
          <p:cNvSpPr/>
          <p:nvPr/>
        </p:nvSpPr>
        <p:spPr>
          <a:xfrm>
            <a:off x="6738575" y="5037543"/>
            <a:ext cx="1229300" cy="36537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</a:rPr>
              <a:t>Comparator Group: Fenland</a:t>
            </a:r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ACB94CB8-ECD6-4795-9F68-16C256019DBC}"/>
              </a:ext>
            </a:extLst>
          </p:cNvPr>
          <p:cNvSpPr/>
          <p:nvPr/>
        </p:nvSpPr>
        <p:spPr>
          <a:xfrm>
            <a:off x="4774821" y="78553"/>
            <a:ext cx="3194101" cy="3045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u="sng" dirty="0">
                <a:solidFill>
                  <a:schemeClr val="tx1"/>
                </a:solidFill>
              </a:rPr>
              <a:t>Evaluation Design of the Peterborough Exemplar</a:t>
            </a:r>
            <a:endParaRPr lang="en-GB" sz="1200" u="sng" dirty="0">
              <a:solidFill>
                <a:schemeClr val="tx1"/>
              </a:solidFill>
            </a:endParaRP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F67892B3-5A8F-4700-B096-4988D3E15DAE}"/>
              </a:ext>
            </a:extLst>
          </p:cNvPr>
          <p:cNvSpPr/>
          <p:nvPr/>
        </p:nvSpPr>
        <p:spPr>
          <a:xfrm>
            <a:off x="107144" y="995827"/>
            <a:ext cx="200346" cy="572599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</a:rPr>
              <a:t>T0 – T3 (18 months)</a:t>
            </a:r>
            <a:endParaRPr lang="en-GB" sz="8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51636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5</TotalTime>
  <Words>363</Words>
  <Application>Microsoft Office PowerPoint</Application>
  <PresentationFormat>Widescreen</PresentationFormat>
  <Paragraphs>6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da Efstathopoulou</dc:creator>
  <cp:lastModifiedBy>Lida Efstathopoulou</cp:lastModifiedBy>
  <cp:revision>61</cp:revision>
  <dcterms:created xsi:type="dcterms:W3CDTF">2021-03-04T11:34:51Z</dcterms:created>
  <dcterms:modified xsi:type="dcterms:W3CDTF">2021-09-20T13:39:45Z</dcterms:modified>
</cp:coreProperties>
</file>